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8" d="100"/>
          <a:sy n="98" d="100"/>
        </p:scale>
        <p:origin x="1200" y="-3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FCCF23-2B10-4A42-9C0E-F6C568A9F7A5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7B6712-614B-4F5F-B9F5-B87A88D8AA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0104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7B6712-614B-4F5F-B9F5-B87A88D8AA5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88888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323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5832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607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6575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4559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822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0276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7524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40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0171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002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272A3A-4A15-4E6F-A2AC-83FE5E59E39F}" type="datetimeFigureOut">
              <a:rPr lang="zh-CN" altLang="en-US" smtClean="0"/>
              <a:t>2017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2E1C35-EAAC-47F7-B3D8-13A4B565220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3102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177099" y="0"/>
            <a:ext cx="6444765" cy="8963130"/>
            <a:chOff x="177099" y="0"/>
            <a:chExt cx="6444765" cy="8963130"/>
          </a:xfrm>
        </p:grpSpPr>
        <p:sp>
          <p:nvSpPr>
            <p:cNvPr id="2" name="矩形 1"/>
            <p:cNvSpPr/>
            <p:nvPr/>
          </p:nvSpPr>
          <p:spPr>
            <a:xfrm>
              <a:off x="964642" y="0"/>
              <a:ext cx="5657222" cy="896313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A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V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V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V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D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V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V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*CERELQESSLEACRLVVDQQLAGRLPWSTGLQMRCCQQLRDISAKCRPVAVSQVARQYGQ</a:t>
              </a:r>
            </a:p>
            <a:p>
              <a:r>
                <a:rPr lang="en-US" altLang="zh-CN" sz="800" u="sng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MAKRLVLFATVVIGLVALTVA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GEASRQLQCERELQESSLEACRLVVDQQLAGRLPWSTGLQMRCCQQLRDISAKCRPVAVSQVARQYGQ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P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TSPQQGSYYPGQASPQQPGKWQEPGQGQQGYYPTSLQQPGQGQQ-----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P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GKWQELGQGQQGYYPTSLQQPGQGQQ-----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S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GKWQELGQGQQGYYPTSLQQPGQGQQGYYRT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S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GKWQELGQGQQGYYPTSLQQPGQGQQGYYRT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P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GKWQELGQGQQGYYPTSLQQPGQGQQ-----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S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RKWQELGQGQQGYYPTSLQQPGQGQQGYYRT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S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RKWQELGQGQQGYYPTSLQQPGQGQQGYYQT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TAVPPKGGSFYSRETTPLQQLQQGIFGGTSSQTVQ</a:t>
              </a:r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YYPSVISPQQGSYYPGQASPQQPGKWQELGQGQQGYYPTSLQQPGQGQQGHYPA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-------------------TGQGQQGYYPTSLQQPGQ---GQQIGQWQQGYYPTSPQHPGQGQQPGQVQQ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-------------------------GYYRTSLQQPGQ---GQQIGQWQQGYYPTSPQHPGQGQQPGQVQK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LQQPGQGQQ---------------------------GYYRTSLQQPGQ---GQQIGQWQQGYYPTSPQHPGQGQQPGQVQK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LQQPGQGQQ---------------------------GYYRTSLQQPGQ---GQQIGQWQQGYYPTSPQHPGQGQQPGQVQK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-------------------------GYYRTSLQQPGQ---GQQIGQWQQGYYPTSPQHPGQGQQPGQVQK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LQQPGQGQQ---------------------------GYYRTSLQQPGQ---GQQIGQWQQGYYPTSPQHPGQGQQPGQVQK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LQQSGQGQQ---------------------------GYYRTSLQQPGQ---RQQIGQWQQGYYPTSPQHPGQGQQPGQVQKIGQGQQPE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QHQPGQGQQGHHPASLQQSGQGQQIGQAQQ*GQGQQGYYPTSLQQPGQEGQGQQIGQWQQGYYPTSPQHPGQGQQPGQVQKIGQGQQPE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EQPGQGQQIGQGQQIGQGQQPEQGQQP------------------------------GQGQQGYYPTSPQHLGQGQQPGQWQQLGQG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------PGQGQQP------------------------------GQGQQGYYPTSLQQPRQGQQPGQWQ-----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PEQGQQPGQGQQP------------------------------GQGQQGYYPTSPQQPRQGQQPGQWQ-----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PEQGQQPGQGQQP------------------------------GQGQQGYYPTSPQQPRQGQQPGQWQ-----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------PGQGQQP------------------------------GQGQQGYYPTSLQQPRQGQQPGQWQ-----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PEQGQQPGQGQQP------------------------------GQGQQGYYPTSPQQPRQGQQPGQWQ-----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PEQGQQPGQGQQPEKGQQLGQEQQIGQGQQPEQGQQPGQGQQPGQGQQGYYPTSPQQPRQGQQPGQWQ-----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KGQQLGQEQQIGQGQQPEQGQQPGQGQQP------------------------------GQGQQGYYPTSPQQPRQGQQPGQWQ------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PGQWQQPGQGQQPGQGQQGYYPTSLQQPGQGQQGHYPASQHQPGQGQQEHHPASLQQSGQGQQGHHP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QGYYPTSLQQPGQGQQGHYPASQHQPGQGQQGHHPASLQQSGQGQQGHHS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KGYYPTSLQQPGQGQQGHYPASQHQPGQGQQGHHPASLQQSGQGQQGHHP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KGYYPTSLQQPGQGQQGHYPASQHQPGQGQQGHHPASLQQSGQGQQGHHP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QGYYPTSLQQPGQGQQGHYPASQHQPGQGQQGHHPASLQQSGQGQQEHHS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QGYYPTSLQQPGQGQQGHYPASQHQPGQGQQGHHPASLQQSGQGQQGHHP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QGYYPTSLQQPGQGQQGHYPASQHQPGQGQQGHHPASLQQSGQGQQGHHPASLQQPGQGKQTGQREQRQQPG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---QPGQGQKGYYPTSLQQPGQGQQGHYPASQHQPGQGQQGHHPASLQQSGQGQQGHHPASLQQPGQGKQTGQREQRQQPG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QQGYYPTSPQQPGQGQQPEQWEQLGQGQQGHYPASLQQPGQGQQGHYPASLQQPGQGQPGQTQQPGQGQP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QQGYYPTYLQQPGQGQQPEQWQQLGQGQQGHYPASLQQSGQGQQGHYPASLQQPGQGQPGQTQQPGQGQ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RQGYYPTYPQQPGQGQQPEQWQQPGQGQQRHYPASLQQSGQGQQGHYPASLQQPGQGQPGQTQQPGQGQ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QQGYYPTYPQQPGQGQQPEQWQQPGQGQQRHYPASLQQSGQGQQGHYPASLQQPGQGQPGQTQQPGQGQ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QQGYYPTYLQQPGQGQQPEQWQQLGQGQQGHYPASLQQSGQGQQGHYPASLQQPGQGQPGQTQQPGQGQ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QQGYYPTYSQQPGQGQQPEQWQQPGQGQQRHYPASLQQSGQGQQGHYPTSLQQLGQGQPGQTQQPGQGQ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QQGYYPTYPQQPGQGQQPEQWQQPGQGQQRHYPASLQQSGQGQQGHYPTSLQQPGQGQPGQTQQPGQGQ-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GQQTGQGQQPEQEQQPGQGRQGYYPTYPQQSGQGQQPEQWQQPGQGQQRHYPASLQQSGQGQQGHYPASLQQPGQGQPGQTQQPGQGQ-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GQTQQPGQGQPGETQQSGQGQQGYYPTSPQQPGQGQQPGQGQQGHCPTSPQQPGQAQQPGQGQQTGQVQQL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YYPTSPQQPGQGQQPGQGQQGHFPTS----GQAQQPGQGQQIGQAQQL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YYPTSPQQPGQGQQPGQGQQGHFPTF----GQAQQPGQGQQIGQAQQQ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YYPTSPQQPGQGQQPGQGQQGHFPTS----GQAQQPGQGQQIGQAQQL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YYPTSPQQPGQGQQPGQGQQGHFPTS----GQAQQPGQGQQIGQAQQL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YYPTSPQQPGQGQQPGQGQQGHFPTS----GQAQQPGQGQQIGQAQQL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YYPTSPQQPGQGQQPGQGQQGHFPTS----GQAQQPGQGQQIGHAQQLGQGQQGYYPTSLQQPGQEQ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---------HPEQEEQPGQGQQG*YPTSPQQPGQGQQPGQGQQGHFPTF----GQAQQPGQGQQIGQAQQ*GQGQQGYYPTSLQQPGQEQ</a:t>
              </a:r>
            </a:p>
            <a:p>
              <a:endParaRPr lang="zh-CN" altLang="en-US" sz="80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E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NPYHVSVEQQVASPKVAKAH*PTAQLPTMCQMEGGDALSASQ 630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TLSASQ 587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ALSASQ 608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ALSASQ 608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ALSASQ 587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ALSASQ 608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ALSASQ 637</a:t>
              </a:r>
            </a:p>
            <a:p>
              <a:r>
                <a:rPr lang="en-US" altLang="zh-CN" sz="80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QSGQGQQLGQGHQPGQGQQSGQEQQGYD</a:t>
              </a:r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SPYHVSVEQQAASPKVAKAHHPVAQLPTMCQMEGGDALSASQ 635</a:t>
              </a:r>
            </a:p>
          </p:txBody>
        </p:sp>
        <p:sp>
          <p:nvSpPr>
            <p:cNvPr id="3" name="矩形 2"/>
            <p:cNvSpPr/>
            <p:nvPr/>
          </p:nvSpPr>
          <p:spPr>
            <a:xfrm>
              <a:off x="177101" y="4511713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4" name="矩形 3"/>
            <p:cNvSpPr/>
            <p:nvPr/>
          </p:nvSpPr>
          <p:spPr>
            <a:xfrm>
              <a:off x="177101" y="3434495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5" name="矩形 4"/>
            <p:cNvSpPr/>
            <p:nvPr/>
          </p:nvSpPr>
          <p:spPr>
            <a:xfrm>
              <a:off x="177100" y="2317085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6" name="矩形 5"/>
            <p:cNvSpPr/>
            <p:nvPr/>
          </p:nvSpPr>
          <p:spPr>
            <a:xfrm>
              <a:off x="177100" y="1224794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7" name="矩形 6"/>
            <p:cNvSpPr/>
            <p:nvPr/>
          </p:nvSpPr>
          <p:spPr>
            <a:xfrm>
              <a:off x="177100" y="132505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8" name="矩形 7"/>
            <p:cNvSpPr/>
            <p:nvPr/>
          </p:nvSpPr>
          <p:spPr>
            <a:xfrm>
              <a:off x="177100" y="5609027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9" name="矩形 8"/>
            <p:cNvSpPr/>
            <p:nvPr/>
          </p:nvSpPr>
          <p:spPr>
            <a:xfrm>
              <a:off x="177100" y="6718435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10" name="矩形 9"/>
            <p:cNvSpPr/>
            <p:nvPr/>
          </p:nvSpPr>
          <p:spPr>
            <a:xfrm>
              <a:off x="177099" y="7805528"/>
              <a:ext cx="928217" cy="10772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1Ay-P1428339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JQ240472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  <a:endParaRPr lang="en-US" altLang="zh-CN" sz="800" b="0" dirty="0" smtClean="0">
                <a:solidFill>
                  <a:srgbClr val="000000"/>
                </a:solidFill>
                <a:latin typeface="Courier New" panose="02070309020205020404" pitchFamily="49" charset="0"/>
              </a:endParaRP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8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3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4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FJ40459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EU984505    </a:t>
              </a:r>
              <a:r>
                <a:rPr lang="en-US" altLang="zh-CN" sz="800" b="0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   </a:t>
              </a:r>
            </a:p>
            <a:p>
              <a:r>
                <a:rPr lang="en-US" altLang="zh-CN" sz="800" b="1" dirty="0" smtClean="0">
                  <a:solidFill>
                    <a:srgbClr val="000000"/>
                  </a:solidFill>
                  <a:latin typeface="Courier New" panose="02070309020205020404" pitchFamily="49" charset="0"/>
                </a:rPr>
                <a:t>AY245579 </a:t>
              </a:r>
              <a:endParaRPr lang="zh-CN" altLang="en-US" dirty="0"/>
            </a:p>
          </p:txBody>
        </p:sp>
        <p:sp>
          <p:nvSpPr>
            <p:cNvPr id="11" name="矩形 10"/>
            <p:cNvSpPr/>
            <p:nvPr/>
          </p:nvSpPr>
          <p:spPr>
            <a:xfrm>
              <a:off x="2923162" y="3219855"/>
              <a:ext cx="64800" cy="1070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矩形 11"/>
            <p:cNvSpPr/>
            <p:nvPr/>
          </p:nvSpPr>
          <p:spPr>
            <a:xfrm>
              <a:off x="2803213" y="894053"/>
              <a:ext cx="64800" cy="1070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矩形 12"/>
            <p:cNvSpPr/>
            <p:nvPr/>
          </p:nvSpPr>
          <p:spPr>
            <a:xfrm>
              <a:off x="5277304" y="7608975"/>
              <a:ext cx="64800" cy="1070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矩形 13"/>
            <p:cNvSpPr/>
            <p:nvPr/>
          </p:nvSpPr>
          <p:spPr>
            <a:xfrm>
              <a:off x="3954114" y="7850377"/>
              <a:ext cx="64800" cy="1070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矩形 14"/>
            <p:cNvSpPr/>
            <p:nvPr/>
          </p:nvSpPr>
          <p:spPr>
            <a:xfrm>
              <a:off x="2440359" y="7601660"/>
              <a:ext cx="64800" cy="1070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等腰三角形 15"/>
            <p:cNvSpPr/>
            <p:nvPr/>
          </p:nvSpPr>
          <p:spPr>
            <a:xfrm rot="10800000">
              <a:off x="3589951" y="92987"/>
              <a:ext cx="54000" cy="7903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等腰三角形 16"/>
            <p:cNvSpPr/>
            <p:nvPr/>
          </p:nvSpPr>
          <p:spPr>
            <a:xfrm rot="10800000">
              <a:off x="2872015" y="102662"/>
              <a:ext cx="54000" cy="7903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等腰三角形 17"/>
            <p:cNvSpPr/>
            <p:nvPr/>
          </p:nvSpPr>
          <p:spPr>
            <a:xfrm rot="10800000">
              <a:off x="4912355" y="92986"/>
              <a:ext cx="54000" cy="7903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等腰三角形 18"/>
            <p:cNvSpPr/>
            <p:nvPr/>
          </p:nvSpPr>
          <p:spPr>
            <a:xfrm rot="10800000">
              <a:off x="4987418" y="92986"/>
              <a:ext cx="54000" cy="7903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等腰三角形 19"/>
            <p:cNvSpPr/>
            <p:nvPr/>
          </p:nvSpPr>
          <p:spPr>
            <a:xfrm rot="10800000">
              <a:off x="5581095" y="95838"/>
              <a:ext cx="54000" cy="7903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等腰三角形 20"/>
            <p:cNvSpPr/>
            <p:nvPr/>
          </p:nvSpPr>
          <p:spPr>
            <a:xfrm rot="10800000">
              <a:off x="3775766" y="6684315"/>
              <a:ext cx="54000" cy="79035"/>
            </a:xfrm>
            <a:prstGeom prst="triangl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等腰三角形 21"/>
            <p:cNvSpPr/>
            <p:nvPr/>
          </p:nvSpPr>
          <p:spPr>
            <a:xfrm rot="10800000">
              <a:off x="4499097" y="7784990"/>
              <a:ext cx="54000" cy="7903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4" name="矩形 23"/>
          <p:cNvSpPr/>
          <p:nvPr/>
        </p:nvSpPr>
        <p:spPr>
          <a:xfrm>
            <a:off x="183571" y="8900969"/>
            <a:ext cx="6360179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1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Fig.</a:t>
            </a:r>
            <a:r>
              <a:rPr lang="en-US" altLang="zh-CN" sz="11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the </a:t>
            </a:r>
            <a:r>
              <a:rPr lang="en-US" altLang="zh-CN" sz="11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duced amino </a:t>
            </a:r>
            <a:r>
              <a:rPr lang="en-US" altLang="zh-CN" sz="11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id sequences of </a:t>
            </a:r>
            <a:r>
              <a:rPr lang="en-US" altLang="zh-CN" sz="11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Ay</a:t>
            </a:r>
            <a:r>
              <a:rPr lang="en-US" altLang="zh-CN" sz="11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 </a:t>
            </a:r>
            <a:r>
              <a:rPr lang="en-US" altLang="zh-CN" sz="11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altLang="zh-CN" sz="1100" i="1" kern="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T. </a:t>
            </a:r>
            <a:r>
              <a:rPr lang="en-US" altLang="zh-CN" sz="1100" i="1" kern="0" dirty="0" err="1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urartu</a:t>
            </a:r>
            <a:r>
              <a:rPr lang="en-US" altLang="zh-CN" sz="11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ignal peptide was underlined, N-terminal and C-terminal regions were in bold respectively. Conserved cysteine residues were indicated by solid arrows while the new cysteine residue appeared in </a:t>
            </a:r>
            <a:r>
              <a:rPr lang="en-US" altLang="zh-CN" sz="11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Ay-PI428339 </a:t>
            </a:r>
            <a:r>
              <a:rPr lang="en-US" altLang="zh-CN" sz="11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marked by hollow arrows. The in frame stop codons were indicated by asterisks and boxed.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2372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8</TotalTime>
  <Words>284</Words>
  <Application>Microsoft Office PowerPoint</Application>
  <PresentationFormat>A4 纸张(210x297 毫米)</PresentationFormat>
  <Paragraphs>13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仿宋</vt:lpstr>
      <vt:lpstr>宋体</vt:lpstr>
      <vt:lpstr>Arial</vt:lpstr>
      <vt:lpstr>Calibri</vt:lpstr>
      <vt:lpstr>Calibri Light</vt:lpstr>
      <vt:lpstr>Courier New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zy</dc:creator>
  <cp:lastModifiedBy>dzy</cp:lastModifiedBy>
  <cp:revision>10</cp:revision>
  <dcterms:created xsi:type="dcterms:W3CDTF">2017-05-08T06:48:10Z</dcterms:created>
  <dcterms:modified xsi:type="dcterms:W3CDTF">2017-06-20T09:56:15Z</dcterms:modified>
</cp:coreProperties>
</file>